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1" d="100"/>
          <a:sy n="101" d="100"/>
        </p:scale>
        <p:origin x="-1864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437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6594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112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793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1813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170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510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363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310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8332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049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19178-694A-EC46-8F2D-3A48F52DD7FA}" type="datetimeFigureOut">
              <a:rPr lang="en-US" smtClean="0"/>
              <a:t>7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B1DBF-86F9-E44C-BF37-F960285BA3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825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6228" y="0"/>
            <a:ext cx="7397262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14342" y="708147"/>
            <a:ext cx="11190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/>
                <a:cs typeface="Helvetica"/>
              </a:rPr>
              <a:t>Data</a:t>
            </a:r>
          </a:p>
          <a:p>
            <a:pPr algn="ctr"/>
            <a:r>
              <a:rPr lang="en-US" dirty="0" smtClean="0">
                <a:latin typeface="Helvetica"/>
                <a:cs typeface="Helvetica"/>
              </a:rPr>
              <a:t>2D SFS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4342" y="2231202"/>
            <a:ext cx="111903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/>
                <a:cs typeface="Helvetica"/>
              </a:rPr>
              <a:t>Model</a:t>
            </a:r>
          </a:p>
          <a:p>
            <a:pPr algn="ctr"/>
            <a:r>
              <a:rPr lang="en-US" dirty="0" smtClean="0">
                <a:latin typeface="Helvetica"/>
                <a:cs typeface="Helvetica"/>
              </a:rPr>
              <a:t>2D SFS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51476" y="3905158"/>
            <a:ext cx="1232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/>
                <a:cs typeface="Helvetica"/>
              </a:rPr>
              <a:t>Residuals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51476" y="5428212"/>
            <a:ext cx="12321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Helvetica"/>
                <a:cs typeface="Helvetica"/>
              </a:rPr>
              <a:t>Residuals</a:t>
            </a:r>
          </a:p>
          <a:p>
            <a:pPr algn="ctr"/>
            <a:r>
              <a:rPr lang="en-US" dirty="0" smtClean="0">
                <a:latin typeface="Helvetica"/>
                <a:cs typeface="Helvetica"/>
              </a:rPr>
              <a:t>Histogram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809739" y="726178"/>
            <a:ext cx="264041" cy="51556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6904312" y="1685028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/>
          <p:cNvSpPr/>
          <p:nvPr/>
        </p:nvSpPr>
        <p:spPr>
          <a:xfrm>
            <a:off x="4592328" y="1697603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2305489" y="1685028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6916885" y="3258384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/>
          <p:cNvSpPr/>
          <p:nvPr/>
        </p:nvSpPr>
        <p:spPr>
          <a:xfrm>
            <a:off x="4604901" y="3270959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2318062" y="3258384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6904312" y="4831741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4592328" y="4844316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2305489" y="4831741"/>
            <a:ext cx="528082" cy="213772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2032915" y="1634207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/>
                <a:cs typeface="Helvetica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asmati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56640" y="1632718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284240" y="1634220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2" name="Rectangle 21"/>
          <p:cNvSpPr/>
          <p:nvPr/>
        </p:nvSpPr>
        <p:spPr>
          <a:xfrm>
            <a:off x="1496237" y="801185"/>
            <a:ext cx="264041" cy="51556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/>
          <p:cNvSpPr/>
          <p:nvPr/>
        </p:nvSpPr>
        <p:spPr>
          <a:xfrm>
            <a:off x="6057921" y="747723"/>
            <a:ext cx="264041" cy="51556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1104390" y="843495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3407228" y="843496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5699582" y="843497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Basmati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7" name="Rectangle 26"/>
          <p:cNvSpPr/>
          <p:nvPr/>
        </p:nvSpPr>
        <p:spPr>
          <a:xfrm>
            <a:off x="1449414" y="2311064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/>
          <p:cNvSpPr/>
          <p:nvPr/>
        </p:nvSpPr>
        <p:spPr>
          <a:xfrm>
            <a:off x="3733359" y="2311064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6006687" y="2298489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1449412" y="3892583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3733357" y="3892583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/>
          <p:nvPr/>
        </p:nvSpPr>
        <p:spPr>
          <a:xfrm>
            <a:off x="6006685" y="3880008"/>
            <a:ext cx="340421" cy="566469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/>
          <p:cNvSpPr txBox="1"/>
          <p:nvPr/>
        </p:nvSpPr>
        <p:spPr>
          <a:xfrm>
            <a:off x="2032915" y="4794003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/>
                <a:cs typeface="Helvetica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asmati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956640" y="4792514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284240" y="4794016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 rot="16200000">
            <a:off x="1104390" y="4003291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3407228" y="4003292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5699582" y="4003293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Basmati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021672" y="3208071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Helvetica"/>
                <a:cs typeface="Helvetica"/>
              </a:rPr>
              <a:t>B</a:t>
            </a:r>
            <a:r>
              <a:rPr lang="en-US" sz="1200" dirty="0" smtClean="0">
                <a:latin typeface="Helvetica"/>
                <a:cs typeface="Helvetica"/>
              </a:rPr>
              <a:t>asmati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945397" y="3206582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6272997" y="3208084"/>
            <a:ext cx="18482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Tropical japonica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1093147" y="2417359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395985" y="2417360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Aus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5688339" y="2417361"/>
            <a:ext cx="1119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Helvetica"/>
                <a:cs typeface="Helvetica"/>
              </a:rPr>
              <a:t>Basmati</a:t>
            </a:r>
            <a:endParaRPr lang="en-US" sz="1200" dirty="0">
              <a:latin typeface="Helvetica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1898483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3</Words>
  <Application>Microsoft Macintosh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e Young Choi</dc:creator>
  <cp:lastModifiedBy>Jae Young Choi</cp:lastModifiedBy>
  <cp:revision>2</cp:revision>
  <dcterms:created xsi:type="dcterms:W3CDTF">2019-07-09T12:43:51Z</dcterms:created>
  <dcterms:modified xsi:type="dcterms:W3CDTF">2019-07-09T12:55:09Z</dcterms:modified>
</cp:coreProperties>
</file>